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9A8690-E6A9-4A07-A637-B676A685F2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7B078B0-5DF3-4272-B8BC-45607834BE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911C544-EE49-4196-A4ED-47FBB2AED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AAF57E5-6BDE-4465-BFB5-A8B33A003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C5B5B27-5195-4104-81FD-A00BB449B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94524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2769B28-E38A-4E46-8764-102DB5AEF4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D30AA43-C1DB-42A2-8C07-07FFFDC8FD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BD05387-B675-4C7A-BBCF-F37BEB13E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C9D223B-A1E9-4622-9AFC-7DA6BD0E4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6ACDC8C-BB59-4D24-B3B9-85BBB80B2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77818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D65BA93-55CF-4D39-B952-425ECBE333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244AE65-6831-4A58-8CA7-34A100CEF7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7B54529-CB88-4E6C-A6BE-D1C0CD70D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B34FC72-8208-4442-A369-BE8FC1B56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58EA5E5-E24B-4DFF-85BB-0FD53905C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611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76B811C-5FB3-46DA-808C-B3648EF79B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EB687C8-A6EE-44FE-8A4F-B8B3D12DB8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5007EAF-65C8-4204-9BCD-03C04EAB0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200AAAA-28CF-4743-9593-E543C3948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0A572A1-8E61-42C5-BD4C-890E4D6996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49595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7A0EF6C-BD3C-4115-A2B1-76E550D07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E9DDD51-0876-4F9F-87E3-4F8254A21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EA1EC6E-7F85-443B-A758-94908AEF3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6E7B88A-4842-4265-B267-D8F9ACF37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A3AAD20-82F8-4B82-B0BA-FFB5BCE7CA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45603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A7CB607-E0D0-45BC-900A-FDA64A3881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9629ED1-B916-4AA0-B2E6-C21085C88B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0C1EFEF-91D6-4AFD-ABA5-0E24D2B51E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CEEDD74-64E6-4F98-BD0A-8F038E794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92A9C59-0074-42CD-9D0D-1D29F1C18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5B520BB-C314-4600-B25F-6EC753851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75165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E3F453-61CB-4F68-B07C-B8731E4C46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F750A9A-C4BE-413D-BBEB-1EDF618D14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3F5ECE7-7619-403E-81FC-E49D1147E3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89CA1A5-8182-4823-814C-95E2CB0949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2CD1217-FFD5-4EB9-B5C6-1453B5AC7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D0E338C8-307A-4D84-8EA7-71FD8470C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C51C894-93F3-431D-B64C-82A66175E0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42FC3FC-5D46-44CE-A9F4-3E2424F4E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69501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742C051-076B-4F14-BCCA-D31D3E737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48E4179-C02A-475C-8246-C3F4CBB93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8A46863-2905-4439-B200-D37354F9E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A5FEDEB-A482-4967-9036-2EE202ACD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6870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A0F19200-7BB9-4228-9165-14A20C8EB9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4C7BB71-228E-4EB2-B4B8-5955299F4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8D5EE9F-9E44-46A7-A987-8B07FE8952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36750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5B0340F-8C25-4A4F-9368-EA336224E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2D8A04B-A8DC-4BF5-87EB-FFF0609324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28FDAE8-216A-460D-A4FF-ECD54A0071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115F10D-7965-4E6C-BA79-7DF3EED60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FC93EE2-803C-4E86-AD36-E54067D6E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9E4A3A1-EF6F-427E-AD1A-BAD3810C0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14312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B5F869D-B1CB-4C0B-A7A2-7E4C01C754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EFE5868-9133-4B4D-B556-898CE225D2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203B5BE-542E-47B9-9198-EB2BFC0238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D3F337A-4373-4770-A1F8-E183F3339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DC312E9-5FE9-42D0-8D0F-DB28F3487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D17C221-A651-4710-922B-2D8F22857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16485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6EE71D5A-D761-4051-A357-C7414585E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09CC83B-EE17-41B8-B095-A331A44C37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A6EDD87-51D7-43DB-BA3A-508C253938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C5CEFD-964E-429A-BEAB-9A621C147D65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8A7A52D-59FC-46BB-8024-08F5A7F14B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F72C4CF-EC33-4B84-A376-4A97CAACD0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BFA21F-3881-4F64-AA8B-E57AEBBE933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66358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>
            <a:extLst>
              <a:ext uri="{FF2B5EF4-FFF2-40B4-BE49-F238E27FC236}">
                <a16:creationId xmlns:a16="http://schemas.microsoft.com/office/drawing/2014/main" id="{7D4BBAE4-278B-48CF-8C04-C60AC22E7B9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028405" y="849493"/>
            <a:ext cx="5943600" cy="2825115"/>
          </a:xfrm>
          <a:prstGeom prst="rect">
            <a:avLst/>
          </a:prstGeom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id="{6090CE4F-BBE2-4C8B-9A4F-592C72A39537}"/>
              </a:ext>
            </a:extLst>
          </p:cNvPr>
          <p:cNvSpPr/>
          <p:nvPr/>
        </p:nvSpPr>
        <p:spPr>
          <a:xfrm>
            <a:off x="3067595" y="4207810"/>
            <a:ext cx="6096000" cy="2308324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nockout and overexpressing strains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Gene replacement diagram of the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nockout. Double-joint technique was used. First round PCR was the amplification of 5’ and 3’ flanking regions of the gene and the amplification of the gene marker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h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(1). Second round PCR was the fusion of the three fragments (2). Third round PCR was the amplification of the fused knockout construct (3). b) Confirmation of the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knockout. Diagram of the WT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(top) and a diagram of the correct replacement by the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h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(bottom), fragment sizes for the internal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amplification (178 bp) and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h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(1400 bp) are indicated. 5’ and 3’ fragments were used as controls to the correct insertion of the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h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struction. c) Gene overexpressing diagram of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UE08 plasmid was used and the complete sequence of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gene obtained from cDNA (2721 bp) was inserted in the multiple site cloning. The plasmid has the constitutive promotor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ki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rotein kinase 1) and the terminator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trpc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Tryptophan synthase transcription terminator). </a:t>
            </a:r>
            <a:endParaRPr lang="es-MX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41881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12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ina Guzmán Guzmán</dc:creator>
  <cp:lastModifiedBy>Paulina Guzmán Guzmán</cp:lastModifiedBy>
  <cp:revision>1</cp:revision>
  <dcterms:created xsi:type="dcterms:W3CDTF">2019-09-06T14:32:27Z</dcterms:created>
  <dcterms:modified xsi:type="dcterms:W3CDTF">2019-09-06T14:34:03Z</dcterms:modified>
</cp:coreProperties>
</file>